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>
        <p:scale>
          <a:sx n="50" d="100"/>
          <a:sy n="50" d="100"/>
        </p:scale>
        <p:origin x="2622" y="14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D07ABCF-C88B-4626-8C8F-9638ECA4B54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0ED737F-D48A-48D6-ADEA-08C42572E99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D8AF6BE-9094-48D2-A34F-408ECFBF58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0F397-93D3-48B8-B71A-1A3AA2773979}" type="datetimeFigureOut">
              <a:rPr lang="zh-CN" altLang="en-US" smtClean="0"/>
              <a:t>2021/2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7FF8639-6C48-4A9C-B364-BEDAA7D9A7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0C38C77-FCA2-40A7-BE52-C68DAA0033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44051B-8A43-482E-9D87-EF66A6D015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94221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942547F-23CF-453C-8FB7-CA4814A5EF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D4F827B-5168-4ECD-A79A-19C18E1376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A5A7F0B-8333-4DEF-8AA1-2E47C6C141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0F397-93D3-48B8-B71A-1A3AA2773979}" type="datetimeFigureOut">
              <a:rPr lang="zh-CN" altLang="en-US" smtClean="0"/>
              <a:t>2021/2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1A1B60E-41D9-4D43-AA17-39E2424716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C9996A6-B1F0-4253-AB84-D8B249EDBE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44051B-8A43-482E-9D87-EF66A6D015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68835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16A3F58-229D-4CBD-B2AA-678BE250207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0BF98B9-10C1-4158-ACAE-AF0BE6084F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F824B83-4CBB-4204-B3C6-D7625E8D5E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0F397-93D3-48B8-B71A-1A3AA2773979}" type="datetimeFigureOut">
              <a:rPr lang="zh-CN" altLang="en-US" smtClean="0"/>
              <a:t>2021/2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732FA9C-561D-4AB4-90D1-D1B71D898B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F9FE747-BF8E-4AA6-9B85-B0AEEDDD59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44051B-8A43-482E-9D87-EF66A6D015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07257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E9DD427-E82F-4368-A0C2-2A04402BA2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5429CFC-B523-4143-BC82-3D67B339DDC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D9539FE-6B60-489A-BC1B-799A337DC9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0F397-93D3-48B8-B71A-1A3AA2773979}" type="datetimeFigureOut">
              <a:rPr lang="zh-CN" altLang="en-US" smtClean="0"/>
              <a:t>2021/2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68C7188-A38D-4C11-A0D7-88BA31270D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1F10D05-B293-4B66-817B-0FF9CB9D28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44051B-8A43-482E-9D87-EF66A6D015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09270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778FB69-969B-4B83-B204-F0D825018F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440AE28-5047-4CED-8C3A-9658C6A7B4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A67233F-0494-46B8-B6B6-E6A9454B36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0F397-93D3-48B8-B71A-1A3AA2773979}" type="datetimeFigureOut">
              <a:rPr lang="zh-CN" altLang="en-US" smtClean="0"/>
              <a:t>2021/2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05A0D5E-C7C7-4115-ADE8-1292E6ABFC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69FCA57-7DD0-4866-BC23-39CFBC91C0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44051B-8A43-482E-9D87-EF66A6D015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20384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3B6DE45-6FE8-4993-AAB8-7F4F821AFD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ABEA9A9-E437-4C10-B6CB-6A275F31766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ADE3D84-CB73-4A37-B268-9B19431F4B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4BFB7CA-77D5-4C2D-8CC3-551847C358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0F397-93D3-48B8-B71A-1A3AA2773979}" type="datetimeFigureOut">
              <a:rPr lang="zh-CN" altLang="en-US" smtClean="0"/>
              <a:t>2021/2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C570A00-1680-4DA4-9DC7-36830D6D2C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21CD927-53D4-43F0-8284-417FE2BE1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44051B-8A43-482E-9D87-EF66A6D015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62378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0356465-ACCA-4374-9F8D-ED0EEBB2A4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5E65712-C872-4AEA-A2E0-4B4587DB7C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B3BBE6D-C5C0-41C2-84C5-D671943EF2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515DDEF-4608-40E8-90B2-DEFFA28A628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B3BD4B6-B34E-4EC4-A520-BC382DCCF5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524CAF6-3C20-4144-9933-70F3F07660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0F397-93D3-48B8-B71A-1A3AA2773979}" type="datetimeFigureOut">
              <a:rPr lang="zh-CN" altLang="en-US" smtClean="0"/>
              <a:t>2021/2/2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FF90CB5-4A94-430D-83C5-B4F4271C44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0F43DF9-BF0A-48DB-A806-5417473CA5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44051B-8A43-482E-9D87-EF66A6D015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4344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1FE747-DA2F-4922-91A8-9FD6D6C344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07AB3A0-1EB3-42A5-A87C-A82D77F821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0F397-93D3-48B8-B71A-1A3AA2773979}" type="datetimeFigureOut">
              <a:rPr lang="zh-CN" altLang="en-US" smtClean="0"/>
              <a:t>2021/2/2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C43AF93-2817-4FBE-98AF-CAC1DB6288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585D886-DAFF-4A51-A448-89C1128C8B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44051B-8A43-482E-9D87-EF66A6D015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186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166DFDB-2729-464B-ACB0-16DBB4B2FE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0F397-93D3-48B8-B71A-1A3AA2773979}" type="datetimeFigureOut">
              <a:rPr lang="zh-CN" altLang="en-US" smtClean="0"/>
              <a:t>2021/2/2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ADD3826-DB6D-4AF7-8B40-46877548D9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9F5DB21-1210-44B3-849E-7428F2FA08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44051B-8A43-482E-9D87-EF66A6D015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07852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B101E09-C590-4A25-A3B5-5A27CD1D4B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85247AA-DCD6-4F8F-98BE-C14D11578A3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8693A90-7097-46FA-9421-430E27A3C8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769B4E4-7C7F-40FD-A695-FD5DCDEF8F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0F397-93D3-48B8-B71A-1A3AA2773979}" type="datetimeFigureOut">
              <a:rPr lang="zh-CN" altLang="en-US" smtClean="0"/>
              <a:t>2021/2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1EF4925-659F-446C-A62E-EA3514BC6D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9E6C844-4C98-4AC4-BA89-91D235F24D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44051B-8A43-482E-9D87-EF66A6D015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5351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A70C6D2-E418-4602-88A6-1C92DC618D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83CF0E5-10D9-46C6-AB51-44F3878A97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B82FF37-02BF-4163-81AD-888E102970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BA0D521-030D-484F-9D3E-69B2965D8B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0F397-93D3-48B8-B71A-1A3AA2773979}" type="datetimeFigureOut">
              <a:rPr lang="zh-CN" altLang="en-US" smtClean="0"/>
              <a:t>2021/2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1E304E6-D913-4707-B181-08DA8789C1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054B216-90C6-47D1-8C60-F3EEFEFAFE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44051B-8A43-482E-9D87-EF66A6D015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565863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8A1AA76-436F-4AE1-9639-5F802F6DFB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CAC09C5-D127-42F9-B12B-3CE0E67E6A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E88F281-D184-426D-94C2-2C1BB6D6ED2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F0F397-93D3-48B8-B71A-1A3AA2773979}" type="datetimeFigureOut">
              <a:rPr lang="zh-CN" altLang="en-US" smtClean="0"/>
              <a:t>2021/2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3A442D8-657A-4626-8E87-46585B894AE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AC5FA62-FA53-419A-92F0-E45861D06F8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44051B-8A43-482E-9D87-EF66A6D015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00771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9B7F12FA-E378-4DB2-BCBC-925D93D79A4E}"/>
              </a:ext>
            </a:extLst>
          </p:cNvPr>
          <p:cNvSpPr/>
          <p:nvPr/>
        </p:nvSpPr>
        <p:spPr>
          <a:xfrm>
            <a:off x="5205290" y="1900408"/>
            <a:ext cx="3138508" cy="357660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Times New Roman" panose="02020603050405020304" pitchFamily="18" charset="0"/>
              </a:rPr>
              <a:t>Healthcare Needs</a:t>
            </a:r>
          </a:p>
          <a:p>
            <a:pPr marL="0" marR="0" lvl="0" indent="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Times New Roman" panose="02020603050405020304" pitchFamily="18" charset="0"/>
              </a:rPr>
              <a:t>Indicators:</a:t>
            </a:r>
          </a:p>
          <a:p>
            <a:pPr marL="0" marR="0" lvl="0" indent="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Times New Roman" panose="02020603050405020304" pitchFamily="18" charset="0"/>
              </a:rPr>
              <a:t>1. Cataract prevalence</a:t>
            </a:r>
          </a:p>
          <a:p>
            <a:pPr marL="285750" marR="0" lvl="0" indent="-2857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altLang="zh-CN" sz="18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Times New Roman" panose="02020603050405020304" pitchFamily="18" charset="0"/>
              </a:rPr>
              <a:t>Proxy: Ageing population</a:t>
            </a:r>
          </a:p>
          <a:p>
            <a:pPr marL="0" marR="0" lvl="0" indent="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Times New Roman" panose="02020603050405020304" pitchFamily="18" charset="0"/>
              </a:rPr>
              <a:t>2. Visual acuity cut-off for cataract surgery</a:t>
            </a: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B047E976-D251-4F7C-9828-A268CB5B642A}"/>
              </a:ext>
            </a:extLst>
          </p:cNvPr>
          <p:cNvSpPr/>
          <p:nvPr/>
        </p:nvSpPr>
        <p:spPr>
          <a:xfrm>
            <a:off x="13326141" y="1900407"/>
            <a:ext cx="3155708" cy="357661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rPr>
              <a:t>Enabling Factors</a:t>
            </a:r>
          </a:p>
          <a:p>
            <a:pPr marL="0" marR="0" lvl="0" indent="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Times New Roman" panose="02020603050405020304" pitchFamily="18" charset="0"/>
              </a:rPr>
              <a:t>Indicators:</a:t>
            </a:r>
          </a:p>
          <a:p>
            <a:pPr marL="0" marR="0" lvl="0" indent="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rPr>
              <a:t>1. Paying Ability</a:t>
            </a:r>
            <a:endParaRPr kumimoji="0" lang="en-US" altLang="zh-CN" sz="18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marL="285750" marR="0" lvl="0" indent="-2857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rPr>
              <a:t>Social insurance financing scale per capita</a:t>
            </a:r>
          </a:p>
          <a:p>
            <a:pPr marL="285750" marR="0" lvl="0" indent="-2857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rPr>
              <a:t>Average annual consumption/income scale</a:t>
            </a: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415FA956-09D8-470A-A445-051B50BDFDCA}"/>
              </a:ext>
            </a:extLst>
          </p:cNvPr>
          <p:cNvSpPr/>
          <p:nvPr/>
        </p:nvSpPr>
        <p:spPr>
          <a:xfrm>
            <a:off x="-3147109" y="5971962"/>
            <a:ext cx="19851193" cy="80322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Times New Roman" panose="02020603050405020304" pitchFamily="18" charset="0"/>
              </a:rPr>
              <a:t>Environment Contexts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Times New Roman" panose="02020603050405020304" pitchFamily="18" charset="0"/>
              </a:rPr>
              <a:t>(Economic Development: GDP/P)</a:t>
            </a: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D5EB5B53-E1C8-4F29-A4F7-DCA68AB477A7}"/>
              </a:ext>
            </a:extLst>
          </p:cNvPr>
          <p:cNvSpPr/>
          <p:nvPr/>
        </p:nvSpPr>
        <p:spPr>
          <a:xfrm>
            <a:off x="5535635" y="-603573"/>
            <a:ext cx="2477817" cy="71567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Times New Roman" panose="02020603050405020304" pitchFamily="18" charset="0"/>
              </a:rPr>
              <a:t>Healthcare Utilization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Times New Roman" panose="02020603050405020304" pitchFamily="18" charset="0"/>
              </a:rPr>
              <a:t>(CSR)</a:t>
            </a:r>
          </a:p>
        </p:txBody>
      </p:sp>
      <p:cxnSp>
        <p:nvCxnSpPr>
          <p:cNvPr id="8" name="肘形连接符 36">
            <a:extLst>
              <a:ext uri="{FF2B5EF4-FFF2-40B4-BE49-F238E27FC236}">
                <a16:creationId xmlns:a16="http://schemas.microsoft.com/office/drawing/2014/main" id="{504BD748-0B29-4AAA-9AE2-4ACB20302F11}"/>
              </a:ext>
            </a:extLst>
          </p:cNvPr>
          <p:cNvCxnSpPr>
            <a:stCxn id="15" idx="0"/>
            <a:endCxn id="7" idx="2"/>
          </p:cNvCxnSpPr>
          <p:nvPr/>
        </p:nvCxnSpPr>
        <p:spPr>
          <a:xfrm rot="5400000" flipH="1" flipV="1">
            <a:off x="3752480" y="-1121655"/>
            <a:ext cx="1788304" cy="4255823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肘形连接符 38">
            <a:extLst>
              <a:ext uri="{FF2B5EF4-FFF2-40B4-BE49-F238E27FC236}">
                <a16:creationId xmlns:a16="http://schemas.microsoft.com/office/drawing/2014/main" id="{71C3F8F7-4FD9-4E59-A4A1-AC24C8FB894B}"/>
              </a:ext>
            </a:extLst>
          </p:cNvPr>
          <p:cNvCxnSpPr>
            <a:stCxn id="13" idx="0"/>
            <a:endCxn id="7" idx="2"/>
          </p:cNvCxnSpPr>
          <p:nvPr/>
        </p:nvCxnSpPr>
        <p:spPr>
          <a:xfrm rot="16200000" flipV="1">
            <a:off x="7885757" y="-999108"/>
            <a:ext cx="1788303" cy="4010728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肘形连接符 42">
            <a:extLst>
              <a:ext uri="{FF2B5EF4-FFF2-40B4-BE49-F238E27FC236}">
                <a16:creationId xmlns:a16="http://schemas.microsoft.com/office/drawing/2014/main" id="{E7FB6575-F058-4A5A-A3F1-5782C168F55C}"/>
              </a:ext>
            </a:extLst>
          </p:cNvPr>
          <p:cNvCxnSpPr>
            <a:stCxn id="5" idx="0"/>
            <a:endCxn id="7" idx="2"/>
          </p:cNvCxnSpPr>
          <p:nvPr/>
        </p:nvCxnSpPr>
        <p:spPr>
          <a:xfrm rot="16200000" flipV="1">
            <a:off x="9945119" y="-3058470"/>
            <a:ext cx="1788303" cy="8129451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箭头连接符 10">
            <a:extLst>
              <a:ext uri="{FF2B5EF4-FFF2-40B4-BE49-F238E27FC236}">
                <a16:creationId xmlns:a16="http://schemas.microsoft.com/office/drawing/2014/main" id="{6FE7B909-99FD-4DCE-9F81-333F2D3087F9}"/>
              </a:ext>
            </a:extLst>
          </p:cNvPr>
          <p:cNvCxnSpPr/>
          <p:nvPr/>
        </p:nvCxnSpPr>
        <p:spPr>
          <a:xfrm rot="10800000" flipH="1">
            <a:off x="2523019" y="5477019"/>
            <a:ext cx="1" cy="49494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箭头连接符 11">
            <a:extLst>
              <a:ext uri="{FF2B5EF4-FFF2-40B4-BE49-F238E27FC236}">
                <a16:creationId xmlns:a16="http://schemas.microsoft.com/office/drawing/2014/main" id="{05F4E8B9-1051-46EB-A5F7-163A8D29BECA}"/>
              </a:ext>
            </a:extLst>
          </p:cNvPr>
          <p:cNvCxnSpPr/>
          <p:nvPr/>
        </p:nvCxnSpPr>
        <p:spPr>
          <a:xfrm rot="10800000">
            <a:off x="10785272" y="5477020"/>
            <a:ext cx="0" cy="49494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矩形 12">
            <a:extLst>
              <a:ext uri="{FF2B5EF4-FFF2-40B4-BE49-F238E27FC236}">
                <a16:creationId xmlns:a16="http://schemas.microsoft.com/office/drawing/2014/main" id="{3DE87C7A-3252-40B1-A801-C4A56F01AEB9}"/>
              </a:ext>
            </a:extLst>
          </p:cNvPr>
          <p:cNvSpPr/>
          <p:nvPr/>
        </p:nvSpPr>
        <p:spPr>
          <a:xfrm>
            <a:off x="9207418" y="1900407"/>
            <a:ext cx="3155708" cy="357660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rPr>
              <a:t>Predisposing Characteristics</a:t>
            </a:r>
          </a:p>
          <a:p>
            <a:pPr marL="0" marR="0" lvl="0" indent="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Times New Roman" panose="02020603050405020304" pitchFamily="18" charset="0"/>
              </a:rPr>
              <a:t>Indicators:</a:t>
            </a:r>
          </a:p>
          <a:p>
            <a:pPr marL="0" marR="0" lvl="0" indent="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Times New Roman" panose="02020603050405020304" pitchFamily="18" charset="0"/>
              </a:rPr>
              <a:t>1. Gender Structure</a:t>
            </a:r>
          </a:p>
          <a:p>
            <a:pPr marL="285750" marR="0" lvl="0" indent="-2857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rPr>
              <a:t>Male proportion</a:t>
            </a:r>
          </a:p>
          <a:p>
            <a:pPr marL="0" marR="0" lvl="0" indent="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Times New Roman" panose="02020603050405020304" pitchFamily="18" charset="0"/>
              </a:rPr>
              <a:t>2. Health Beliefs</a:t>
            </a:r>
          </a:p>
          <a:p>
            <a:pPr marL="285750" marR="0" lvl="0" indent="-2857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rPr>
              <a:t>Awareness of cataract and the surgery treatment option</a:t>
            </a:r>
          </a:p>
        </p:txBody>
      </p:sp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49747F6F-BA74-4FFA-A1D3-7E6A107CB91F}"/>
              </a:ext>
            </a:extLst>
          </p:cNvPr>
          <p:cNvCxnSpPr/>
          <p:nvPr/>
        </p:nvCxnSpPr>
        <p:spPr>
          <a:xfrm rot="10800000">
            <a:off x="15126230" y="5477020"/>
            <a:ext cx="0" cy="49494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矩形 14">
            <a:extLst>
              <a:ext uri="{FF2B5EF4-FFF2-40B4-BE49-F238E27FC236}">
                <a16:creationId xmlns:a16="http://schemas.microsoft.com/office/drawing/2014/main" id="{A4FC3F45-C967-4E52-B373-BD2900ADE146}"/>
              </a:ext>
            </a:extLst>
          </p:cNvPr>
          <p:cNvSpPr/>
          <p:nvPr/>
        </p:nvSpPr>
        <p:spPr>
          <a:xfrm>
            <a:off x="945166" y="1900408"/>
            <a:ext cx="3147109" cy="151437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1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Times New Roman" panose="02020603050405020304" pitchFamily="18" charset="0"/>
              </a:rPr>
              <a:t>Human Workforce</a:t>
            </a:r>
          </a:p>
          <a:p>
            <a:pPr marL="0" marR="0" lvl="0" indent="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Times New Roman" panose="02020603050405020304" pitchFamily="18" charset="0"/>
              </a:rPr>
              <a:t>Indicator:</a:t>
            </a:r>
          </a:p>
          <a:p>
            <a:pPr marL="285750" marR="0" lvl="0" indent="-2857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altLang="zh-CN" sz="18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Times New Roman" panose="02020603050405020304" pitchFamily="18" charset="0"/>
              </a:rPr>
              <a:t>Ophthalmologist per million</a:t>
            </a:r>
            <a:endParaRPr kumimoji="0" lang="en-US" altLang="zh-CN" sz="1800" b="1" i="0" u="none" strike="noStrike" kern="1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panose="020F0502020204030204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11940176-B39B-4479-B459-37893AE0AD7C}"/>
              </a:ext>
            </a:extLst>
          </p:cNvPr>
          <p:cNvSpPr/>
          <p:nvPr/>
        </p:nvSpPr>
        <p:spPr>
          <a:xfrm>
            <a:off x="940919" y="3962643"/>
            <a:ext cx="3147109" cy="151437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1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Times New Roman" panose="02020603050405020304" pitchFamily="18" charset="0"/>
              </a:rPr>
              <a:t>General Human Workforce </a:t>
            </a:r>
          </a:p>
          <a:p>
            <a:pPr marL="0" marR="0" lvl="0" indent="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1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Times New Roman" panose="02020603050405020304" pitchFamily="18" charset="0"/>
              </a:rPr>
              <a:t>(Proxy)</a:t>
            </a:r>
          </a:p>
          <a:p>
            <a:pPr marL="0" marR="0" lvl="0" indent="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Times New Roman" panose="02020603050405020304" pitchFamily="18" charset="0"/>
              </a:rPr>
              <a:t>Indicator:</a:t>
            </a:r>
          </a:p>
          <a:p>
            <a:pPr marL="285750" marR="0" lvl="0" indent="-2857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altLang="zh-CN" sz="18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Times New Roman" panose="02020603050405020304" pitchFamily="18" charset="0"/>
              </a:rPr>
              <a:t>General doctor per 1,000</a:t>
            </a:r>
            <a:endParaRPr kumimoji="0" lang="en-US" altLang="zh-CN" sz="1800" b="1" i="0" u="none" strike="noStrike" kern="1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panose="020F0502020204030204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17" name="直接箭头连接符 16">
            <a:extLst>
              <a:ext uri="{FF2B5EF4-FFF2-40B4-BE49-F238E27FC236}">
                <a16:creationId xmlns:a16="http://schemas.microsoft.com/office/drawing/2014/main" id="{55340CB6-D2E1-47C0-8D58-52B48AAFC4B4}"/>
              </a:ext>
            </a:extLst>
          </p:cNvPr>
          <p:cNvCxnSpPr>
            <a:stCxn id="16" idx="0"/>
            <a:endCxn id="15" idx="2"/>
          </p:cNvCxnSpPr>
          <p:nvPr/>
        </p:nvCxnSpPr>
        <p:spPr>
          <a:xfrm flipV="1">
            <a:off x="2514474" y="3414785"/>
            <a:ext cx="4247" cy="54785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矩形 17">
            <a:extLst>
              <a:ext uri="{FF2B5EF4-FFF2-40B4-BE49-F238E27FC236}">
                <a16:creationId xmlns:a16="http://schemas.microsoft.com/office/drawing/2014/main" id="{FA31D35E-9812-4EA8-A0E5-50710A639748}"/>
              </a:ext>
            </a:extLst>
          </p:cNvPr>
          <p:cNvSpPr/>
          <p:nvPr/>
        </p:nvSpPr>
        <p:spPr>
          <a:xfrm>
            <a:off x="-2967844" y="1900408"/>
            <a:ext cx="3147109" cy="358202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1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Times New Roman" panose="02020603050405020304" pitchFamily="18" charset="0"/>
              </a:rPr>
              <a:t>Equipment</a:t>
            </a:r>
          </a:p>
          <a:p>
            <a:pPr marL="0" marR="0" lvl="0" indent="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Times New Roman" panose="02020603050405020304" pitchFamily="18" charset="0"/>
              </a:rPr>
              <a:t>Indicator:</a:t>
            </a:r>
          </a:p>
          <a:p>
            <a:pPr marL="285750" marR="0" lvl="0" indent="-2857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altLang="zh-CN" sz="18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Times New Roman" panose="02020603050405020304" pitchFamily="18" charset="0"/>
              </a:rPr>
              <a:t>Ophthalmic equipment resources</a:t>
            </a:r>
            <a:endParaRPr kumimoji="0" lang="en-US" altLang="zh-CN" sz="1800" b="1" i="0" u="none" strike="noStrike" kern="1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panose="020F0502020204030204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19" name="肘形连接符 39">
            <a:extLst>
              <a:ext uri="{FF2B5EF4-FFF2-40B4-BE49-F238E27FC236}">
                <a16:creationId xmlns:a16="http://schemas.microsoft.com/office/drawing/2014/main" id="{3A73431A-32B7-4B3A-B635-671B6E96AA13}"/>
              </a:ext>
            </a:extLst>
          </p:cNvPr>
          <p:cNvCxnSpPr>
            <a:stCxn id="18" idx="0"/>
            <a:endCxn id="7" idx="2"/>
          </p:cNvCxnSpPr>
          <p:nvPr/>
        </p:nvCxnSpPr>
        <p:spPr>
          <a:xfrm rot="5400000" flipH="1" flipV="1">
            <a:off x="1795975" y="-3078160"/>
            <a:ext cx="1788304" cy="8168833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矩形 19">
            <a:extLst>
              <a:ext uri="{FF2B5EF4-FFF2-40B4-BE49-F238E27FC236}">
                <a16:creationId xmlns:a16="http://schemas.microsoft.com/office/drawing/2014/main" id="{BF374E81-D04A-4E13-9796-60D2484DDD30}"/>
              </a:ext>
            </a:extLst>
          </p:cNvPr>
          <p:cNvSpPr/>
          <p:nvPr/>
        </p:nvSpPr>
        <p:spPr>
          <a:xfrm>
            <a:off x="-3147109" y="552450"/>
            <a:ext cx="7509559" cy="5238750"/>
          </a:xfrm>
          <a:prstGeom prst="rect">
            <a:avLst/>
          </a:prstGeom>
          <a:noFill/>
          <a:ln w="19050" cmpd="sng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rPr>
              <a:t>Healthcare Provisions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宋体" panose="02010600030101010101" pitchFamily="2" charset="-122"/>
              <a:cs typeface="+mn-cs"/>
            </a:endParaRPr>
          </a:p>
        </p:txBody>
      </p: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6ED4CB8A-9F34-4AF1-AB78-618B8702A39A}"/>
              </a:ext>
            </a:extLst>
          </p:cNvPr>
          <p:cNvCxnSpPr/>
          <p:nvPr/>
        </p:nvCxnSpPr>
        <p:spPr>
          <a:xfrm rot="10800000">
            <a:off x="-1394289" y="5482431"/>
            <a:ext cx="0" cy="48953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箭头连接符 21">
            <a:extLst>
              <a:ext uri="{FF2B5EF4-FFF2-40B4-BE49-F238E27FC236}">
                <a16:creationId xmlns:a16="http://schemas.microsoft.com/office/drawing/2014/main" id="{FB30813E-EEBE-45A0-BC6C-D8F1112EB9FA}"/>
              </a:ext>
            </a:extLst>
          </p:cNvPr>
          <p:cNvCxnSpPr>
            <a:stCxn id="6" idx="0"/>
            <a:endCxn id="4" idx="2"/>
          </p:cNvCxnSpPr>
          <p:nvPr/>
        </p:nvCxnSpPr>
        <p:spPr>
          <a:xfrm flipH="1" flipV="1">
            <a:off x="6774544" y="5477016"/>
            <a:ext cx="3944" cy="49494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A3AB28B3-366F-4AF9-AA0D-1A142C826BB5}"/>
              </a:ext>
            </a:extLst>
          </p:cNvPr>
          <p:cNvCxnSpPr>
            <a:stCxn id="4" idx="0"/>
            <a:endCxn id="7" idx="2"/>
          </p:cNvCxnSpPr>
          <p:nvPr/>
        </p:nvCxnSpPr>
        <p:spPr>
          <a:xfrm flipV="1">
            <a:off x="6774544" y="112104"/>
            <a:ext cx="0" cy="178830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矩形 23">
            <a:extLst>
              <a:ext uri="{FF2B5EF4-FFF2-40B4-BE49-F238E27FC236}">
                <a16:creationId xmlns:a16="http://schemas.microsoft.com/office/drawing/2014/main" id="{63D4BF97-EC7F-4DB5-B5A0-7879EEC49B5D}"/>
              </a:ext>
            </a:extLst>
          </p:cNvPr>
          <p:cNvSpPr/>
          <p:nvPr/>
        </p:nvSpPr>
        <p:spPr>
          <a:xfrm>
            <a:off x="4866459" y="552450"/>
            <a:ext cx="11837626" cy="5238750"/>
          </a:xfrm>
          <a:prstGeom prst="rect">
            <a:avLst/>
          </a:prstGeom>
          <a:noFill/>
          <a:ln w="19050" cmpd="sng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rPr>
              <a:t>Healthcare Demands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宋体" panose="02010600030101010101" pitchFamily="2" charset="-122"/>
              <a:cs typeface="+mn-cs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430DBD1F-B202-41A0-86DC-FE8AD3F154C2}"/>
              </a:ext>
            </a:extLst>
          </p:cNvPr>
          <p:cNvSpPr txBox="1"/>
          <p:nvPr/>
        </p:nvSpPr>
        <p:spPr>
          <a:xfrm>
            <a:off x="-3147109" y="6858000"/>
            <a:ext cx="198511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CSR: Cataract Surgery Rate; GDP/P: Gross Domestic Product per Capita</a:t>
            </a:r>
            <a:endParaRPr lang="zh-CN" altLang="zh-CN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993D27EF-743F-49D6-AF60-6E5CEEDC0A7A}"/>
              </a:ext>
            </a:extLst>
          </p:cNvPr>
          <p:cNvSpPr txBox="1"/>
          <p:nvPr/>
        </p:nvSpPr>
        <p:spPr>
          <a:xfrm>
            <a:off x="-3147109" y="7330214"/>
            <a:ext cx="1985119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800" b="1" dirty="0"/>
              <a:t>Supplement 1. Andersen’s healthcare utilization model for Cataract Surgery Rate</a:t>
            </a:r>
            <a:endParaRPr lang="zh-CN" altLang="en-US" sz="2800" b="1" dirty="0"/>
          </a:p>
        </p:txBody>
      </p:sp>
    </p:spTree>
    <p:extLst>
      <p:ext uri="{BB962C8B-B14F-4D97-AF65-F5344CB8AC3E}">
        <p14:creationId xmlns:p14="http://schemas.microsoft.com/office/powerpoint/2010/main" val="11367402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2</Words>
  <Application>Microsoft Office PowerPoint</Application>
  <PresentationFormat>宽屏</PresentationFormat>
  <Paragraphs>3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n Woody</dc:creator>
  <cp:lastModifiedBy>Lin Woody</cp:lastModifiedBy>
  <cp:revision>1</cp:revision>
  <dcterms:created xsi:type="dcterms:W3CDTF">2021-02-21T08:51:39Z</dcterms:created>
  <dcterms:modified xsi:type="dcterms:W3CDTF">2021-02-21T08:52:22Z</dcterms:modified>
</cp:coreProperties>
</file>